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3.xml" ContentType="application/vnd.openxmlformats-officedocument.theme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15.xml" ContentType="application/vnd.openxmlformats-officedocument.presentationml.slideLayout+xml"/>
  <Default Extension="xml" ContentType="application/xml"/>
  <Override PartName="/ppt/notesMasters/notesMaster1.xml" ContentType="application/vnd.openxmlformats-officedocument.presentationml.notesMaster+xml"/>
  <Override PartName="/ppt/slideLayouts/slideLayout13.xml" ContentType="application/vnd.openxmlformats-officedocument.presentationml.slideLayout+xml"/>
  <Override PartName="/ppt/slideLayouts/slideLayout22.xml" ContentType="application/vnd.openxmlformats-officedocument.presentationml.slideLayout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20.xml" ContentType="application/vnd.openxmlformats-officedocument.presentationml.slideLayout+xml"/>
  <Default Extension="jpg" ContentType="image/jpeg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Default Extension="png" ContentType="image/png"/>
  <Override PartName="/ppt/slideMasters/slideMaster2.xml" ContentType="application/vnd.openxmlformats-officedocument.presentationml.slideMaster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charts/style1.xml" ContentType="application/vnd.ms-office.chartstyl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slideLayouts/slideLayout16.xml" ContentType="application/vnd.openxmlformats-officedocument.presentationml.slideLayout+xml"/>
  <Override PartName="/ppt/presentation.xml" ContentType="application/vnd.openxmlformats-officedocument.presentationml.presentation.main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ppt/slideLayouts/slideLayout14.xml" ContentType="application/vnd.openxmlformats-officedocument.presentationml.slideLayout+xml"/>
  <Override PartName="/docProps/app.xml" ContentType="application/vnd.openxmlformats-officedocument.extended-properties+xml"/>
  <Override PartName="/ppt/slideLayouts/slideLayout12.xml" ContentType="application/vnd.openxmlformats-officedocument.presentationml.slideLayout+xml"/>
  <Override PartName="/ppt/slideLayouts/slideLayout2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  <p:sldMasterId id="2147483696" r:id="rId2"/>
  </p:sldMasterIdLst>
  <p:notesMasterIdLst>
    <p:notesMasterId r:id="rId8"/>
  </p:notesMasterIdLst>
  <p:handoutMasterIdLst>
    <p:handoutMasterId r:id="rId9"/>
  </p:handoutMasterIdLst>
  <p:sldIdLst>
    <p:sldId id="269" r:id="rId3"/>
    <p:sldId id="270" r:id="rId4"/>
    <p:sldId id="271" r:id="rId5"/>
    <p:sldId id="267" r:id="rId6"/>
    <p:sldId id="268" r:id="rId7"/>
  </p:sldIdLst>
  <p:sldSz cx="6858000" cy="9144000" type="screen4x3"/>
  <p:notesSz cx="9939338" cy="6805613"/>
  <p:custDataLst>
    <p:tags r:id="rId10"/>
  </p:custDataLst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 showGuides="1">
      <p:cViewPr>
        <p:scale>
          <a:sx n="53" d="100"/>
          <a:sy n="53" d="100"/>
        </p:scale>
        <p:origin x="2214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17" Type="http://schemas.openxmlformats.org/officeDocument/2006/relationships/customXml" Target="../customXml/item3.xml"/><Relationship Id="rId2" Type="http://schemas.openxmlformats.org/officeDocument/2006/relationships/slideMaster" Target="slideMasters/slideMaster2.xml"/><Relationship Id="rId16" Type="http://schemas.openxmlformats.org/officeDocument/2006/relationships/customXml" Target="../customXml/item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5" Type="http://schemas.openxmlformats.org/officeDocument/2006/relationships/customXml" Target="../customXml/item1.xml"/><Relationship Id="rId10" Type="http://schemas.openxmlformats.org/officeDocument/2006/relationships/tags" Target="tags/tag1.xml"/><Relationship Id="rId4" Type="http://schemas.openxmlformats.org/officeDocument/2006/relationships/slide" Target="slides/slide2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koto%20Urai\Documents\&#24863;&#26579;&#30740;2013-15\&#35542;&#25991;\&#12463;&#12522;&#12503;&#12488;&#12467;&#12483;&#12463;&#12473;&#35542;&#25991;\Frontiers%20in%20Cellular%20and%20Infection%20Microbiology&#25237;&#31295;&#29992;\review\CD4%20depletion%20data\20121009FCM-2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koto%20Urai\Documents\&#24863;&#26579;&#30740;2013-14\&#35542;&#25991;\&#12463;&#12522;&#12503;&#12488;&#12467;&#12483;&#12463;&#12473;&#35542;&#25991;\20140218ELISA_EPS-PB-IL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5875941196327"/>
          <c:y val="6.3015329495864303E-2"/>
          <c:w val="0.61459366668733295"/>
          <c:h val="0.77971061631134297"/>
        </c:manualLayout>
      </c:layout>
      <c:lineChart>
        <c:grouping val="standard"/>
        <c:varyColors val="0"/>
        <c:ser>
          <c:idx val="0"/>
          <c:order val="0"/>
          <c:tx>
            <c:strRef>
              <c:f>'RM (2)'!$A$21</c:f>
              <c:strCache>
                <c:ptCount val="1"/>
                <c:pt idx="0">
                  <c:v>control IgG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M (2)'!$B$25:$F$25</c:f>
                <c:numCache>
                  <c:formatCode>General</c:formatCode>
                  <c:ptCount val="5"/>
                  <c:pt idx="0">
                    <c:v>2.89058782889806E-3</c:v>
                  </c:pt>
                  <c:pt idx="1">
                    <c:v>1.4072474572707799E-2</c:v>
                  </c:pt>
                  <c:pt idx="2">
                    <c:v>8.9088908596474104E-4</c:v>
                  </c:pt>
                  <c:pt idx="3">
                    <c:v>7.0296552542005201E-3</c:v>
                  </c:pt>
                  <c:pt idx="4">
                    <c:v>4.2619415092197696E-3</c:v>
                  </c:pt>
                </c:numCache>
              </c:numRef>
            </c:plus>
            <c:minus>
              <c:numRef>
                <c:f>'RM (2)'!$B$25:$F$25</c:f>
                <c:numCache>
                  <c:formatCode>General</c:formatCode>
                  <c:ptCount val="5"/>
                  <c:pt idx="0">
                    <c:v>2.89058782889806E-3</c:v>
                  </c:pt>
                  <c:pt idx="1">
                    <c:v>1.4072474572707799E-2</c:v>
                  </c:pt>
                  <c:pt idx="2">
                    <c:v>8.9088908596474104E-4</c:v>
                  </c:pt>
                  <c:pt idx="3">
                    <c:v>7.0296552542005201E-3</c:v>
                  </c:pt>
                  <c:pt idx="4">
                    <c:v>4.2619415092197696E-3</c:v>
                  </c:pt>
                </c:numCache>
              </c:numRef>
            </c:minus>
          </c:errBars>
          <c:cat>
            <c:numRef>
              <c:f>'RM (2)'!$B$14:$E$14</c:f>
              <c:numCache>
                <c:formatCode>General</c:formatCode>
                <c:ptCount val="4"/>
                <c:pt idx="0">
                  <c:v>-6</c:v>
                </c:pt>
                <c:pt idx="1">
                  <c:v>2</c:v>
                </c:pt>
                <c:pt idx="2">
                  <c:v>6</c:v>
                </c:pt>
                <c:pt idx="3">
                  <c:v>13</c:v>
                </c:pt>
              </c:numCache>
            </c:numRef>
          </c:cat>
          <c:val>
            <c:numRef>
              <c:f>'RM (2)'!$B$21:$E$21</c:f>
              <c:numCache>
                <c:formatCode>0.0%</c:formatCode>
                <c:ptCount val="4"/>
                <c:pt idx="0">
                  <c:v>0.67215128821800296</c:v>
                </c:pt>
                <c:pt idx="1">
                  <c:v>0.54395084580485997</c:v>
                </c:pt>
                <c:pt idx="2">
                  <c:v>0.61055856280197696</c:v>
                </c:pt>
                <c:pt idx="3">
                  <c:v>0.5327020268923420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RM (2)'!$A$22</c:f>
              <c:strCache>
                <c:ptCount val="1"/>
                <c:pt idx="0">
                  <c:v>anti-CD4 IgG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M (2)'!$B$26:$F$26</c:f>
                <c:numCache>
                  <c:formatCode>General</c:formatCode>
                  <c:ptCount val="5"/>
                  <c:pt idx="0">
                    <c:v>8.3700887198986398E-2</c:v>
                  </c:pt>
                  <c:pt idx="1">
                    <c:v>9.2606366067860799E-5</c:v>
                  </c:pt>
                  <c:pt idx="2">
                    <c:v>2.2371364653243899E-3</c:v>
                  </c:pt>
                  <c:pt idx="3">
                    <c:v>1.4523597250582401E-3</c:v>
                  </c:pt>
                  <c:pt idx="4">
                    <c:v>0.13404304029304001</c:v>
                  </c:pt>
                </c:numCache>
              </c:numRef>
            </c:plus>
            <c:minus>
              <c:numRef>
                <c:f>'RM (2)'!$B$26:$F$26</c:f>
                <c:numCache>
                  <c:formatCode>General</c:formatCode>
                  <c:ptCount val="5"/>
                  <c:pt idx="0">
                    <c:v>8.3700887198986398E-2</c:v>
                  </c:pt>
                  <c:pt idx="1">
                    <c:v>9.2606366067860799E-5</c:v>
                  </c:pt>
                  <c:pt idx="2">
                    <c:v>2.2371364653243899E-3</c:v>
                  </c:pt>
                  <c:pt idx="3">
                    <c:v>1.4523597250582401E-3</c:v>
                  </c:pt>
                  <c:pt idx="4">
                    <c:v>0.13404304029304001</c:v>
                  </c:pt>
                </c:numCache>
              </c:numRef>
            </c:minus>
          </c:errBars>
          <c:cat>
            <c:numRef>
              <c:f>'RM (2)'!$B$14:$E$14</c:f>
              <c:numCache>
                <c:formatCode>General</c:formatCode>
                <c:ptCount val="4"/>
                <c:pt idx="0">
                  <c:v>-6</c:v>
                </c:pt>
                <c:pt idx="1">
                  <c:v>2</c:v>
                </c:pt>
                <c:pt idx="2">
                  <c:v>6</c:v>
                </c:pt>
                <c:pt idx="3">
                  <c:v>13</c:v>
                </c:pt>
              </c:numCache>
            </c:numRef>
          </c:cat>
          <c:val>
            <c:numRef>
              <c:f>'RM (2)'!$B$22:$E$22</c:f>
              <c:numCache>
                <c:formatCode>0.0%</c:formatCode>
                <c:ptCount val="4"/>
                <c:pt idx="0">
                  <c:v>0.63629911280101403</c:v>
                </c:pt>
                <c:pt idx="1">
                  <c:v>1.2111745987300501E-3</c:v>
                </c:pt>
                <c:pt idx="2">
                  <c:v>2.2371364653243899E-3</c:v>
                </c:pt>
                <c:pt idx="3">
                  <c:v>7.72195220154727E-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820864"/>
        <c:axId val="161575256"/>
      </c:lineChart>
      <c:catAx>
        <c:axId val="52820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61575256"/>
        <c:crosses val="autoZero"/>
        <c:auto val="1"/>
        <c:lblAlgn val="ctr"/>
        <c:lblOffset val="100"/>
        <c:noMultiLvlLbl val="0"/>
      </c:catAx>
      <c:valAx>
        <c:axId val="161575256"/>
        <c:scaling>
          <c:orientation val="minMax"/>
        </c:scaling>
        <c:delete val="0"/>
        <c:axPos val="l"/>
        <c:numFmt formatCode="0%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52820864"/>
        <c:crosses val="autoZero"/>
        <c:crossBetween val="between"/>
        <c:majorUnit val="0.2"/>
      </c:valAx>
    </c:plotArea>
    <c:legend>
      <c:legendPos val="r"/>
      <c:layout>
        <c:manualLayout>
          <c:xMode val="edge"/>
          <c:yMode val="edge"/>
          <c:x val="0.41192279606781401"/>
          <c:y val="0.41295910820588799"/>
          <c:w val="0.39942890996893099"/>
          <c:h val="0.27656157232155898"/>
        </c:manualLayout>
      </c:layout>
      <c:overlay val="0"/>
      <c:txPr>
        <a:bodyPr/>
        <a:lstStyle/>
        <a:p>
          <a:pPr>
            <a:defRPr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18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M$21</c:f>
              <c:strCache>
                <c:ptCount val="1"/>
                <c:pt idx="0">
                  <c:v>PB-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24:$P$24</c:f>
                <c:numCache>
                  <c:formatCode>General</c:formatCode>
                  <c:ptCount val="3"/>
                  <c:pt idx="0">
                    <c:v>25.416112388132436</c:v>
                  </c:pt>
                  <c:pt idx="1">
                    <c:v>273.46513839347909</c:v>
                  </c:pt>
                  <c:pt idx="2">
                    <c:v>47.779927385895085</c:v>
                  </c:pt>
                </c:numCache>
              </c:numRef>
            </c:plus>
            <c:minus>
              <c:numRef>
                <c:f>Sheet1!$N$24:$P$24</c:f>
                <c:numCache>
                  <c:formatCode>General</c:formatCode>
                  <c:ptCount val="3"/>
                  <c:pt idx="0">
                    <c:v>25.416112388132436</c:v>
                  </c:pt>
                  <c:pt idx="1">
                    <c:v>273.46513839347909</c:v>
                  </c:pt>
                  <c:pt idx="2">
                    <c:v>47.7799273858950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20:$P$20</c:f>
              <c:strCache>
                <c:ptCount val="3"/>
                <c:pt idx="0">
                  <c:v>Control</c:v>
                </c:pt>
                <c:pt idx="1">
                  <c:v>H99EPS</c:v>
                </c:pt>
                <c:pt idx="2">
                  <c:v>JP02EPS</c:v>
                </c:pt>
              </c:strCache>
            </c:strRef>
          </c:cat>
          <c:val>
            <c:numRef>
              <c:f>Sheet1!$N$21:$P$21</c:f>
              <c:numCache>
                <c:formatCode>General</c:formatCode>
                <c:ptCount val="3"/>
                <c:pt idx="0">
                  <c:v>370.17610876226667</c:v>
                </c:pt>
                <c:pt idx="1">
                  <c:v>2533.3199594998</c:v>
                </c:pt>
                <c:pt idx="2">
                  <c:v>466.15091430193337</c:v>
                </c:pt>
              </c:numCache>
            </c:numRef>
          </c:val>
        </c:ser>
        <c:ser>
          <c:idx val="1"/>
          <c:order val="1"/>
          <c:tx>
            <c:strRef>
              <c:f>Sheet1!$M$22</c:f>
              <c:strCache>
                <c:ptCount val="1"/>
                <c:pt idx="0">
                  <c:v>PB+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25:$P$25</c:f>
                <c:numCache>
                  <c:formatCode>General</c:formatCode>
                  <c:ptCount val="3"/>
                  <c:pt idx="0">
                    <c:v>20.912568474697455</c:v>
                  </c:pt>
                  <c:pt idx="1">
                    <c:v>120.70666590479118</c:v>
                  </c:pt>
                  <c:pt idx="2">
                    <c:v>41.172132577167126</c:v>
                  </c:pt>
                </c:numCache>
              </c:numRef>
            </c:plus>
            <c:minus>
              <c:numRef>
                <c:f>Sheet1!$N$25:$P$25</c:f>
                <c:numCache>
                  <c:formatCode>General</c:formatCode>
                  <c:ptCount val="3"/>
                  <c:pt idx="0">
                    <c:v>20.912568474697455</c:v>
                  </c:pt>
                  <c:pt idx="1">
                    <c:v>120.70666590479118</c:v>
                  </c:pt>
                  <c:pt idx="2">
                    <c:v>41.1721325771671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20:$P$20</c:f>
              <c:strCache>
                <c:ptCount val="3"/>
                <c:pt idx="0">
                  <c:v>Control</c:v>
                </c:pt>
                <c:pt idx="1">
                  <c:v>H99EPS</c:v>
                </c:pt>
                <c:pt idx="2">
                  <c:v>JP02EPS</c:v>
                </c:pt>
              </c:strCache>
            </c:strRef>
          </c:cat>
          <c:val>
            <c:numRef>
              <c:f>Sheet1!$N$22:$P$22</c:f>
              <c:numCache>
                <c:formatCode>General</c:formatCode>
                <c:ptCount val="3"/>
                <c:pt idx="0">
                  <c:v>356.70904059446661</c:v>
                </c:pt>
                <c:pt idx="1">
                  <c:v>2913.8107691644</c:v>
                </c:pt>
                <c:pt idx="2">
                  <c:v>488.831816689866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3042856"/>
        <c:axId val="163043240"/>
      </c:barChart>
      <c:catAx>
        <c:axId val="1630428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3043240"/>
        <c:crosses val="autoZero"/>
        <c:auto val="1"/>
        <c:lblAlgn val="ctr"/>
        <c:lblOffset val="100"/>
        <c:noMultiLvlLbl val="0"/>
      </c:catAx>
      <c:valAx>
        <c:axId val="163043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3042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5296521631455726"/>
          <c:y val="0.24535768261463173"/>
          <c:w val="0.20108117791985428"/>
          <c:h val="0.158399260612994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0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7046" cy="3414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629992" y="0"/>
            <a:ext cx="4307046" cy="3414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4AE8F3-E696-4004-A886-DE8A9A5D1881}" type="datetimeFigureOut">
              <a:rPr kumimoji="1" lang="ja-JP" altLang="en-US" smtClean="0"/>
              <a:t>2015/11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464151"/>
            <a:ext cx="4307046" cy="3414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629992" y="6464151"/>
            <a:ext cx="4307046" cy="3414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098B35-A30B-42EA-A08F-29358D9578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8269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7046" cy="3414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2" y="0"/>
            <a:ext cx="4307046" cy="3414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26574B-C10C-4636-98D9-3E017A71A4A9}" type="datetimeFigureOut">
              <a:rPr kumimoji="1" lang="ja-JP" altLang="en-US" smtClean="0"/>
              <a:t>2015/11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08450" y="850900"/>
            <a:ext cx="1722438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4" y="3275201"/>
            <a:ext cx="7951470" cy="26797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64151"/>
            <a:ext cx="4307046" cy="3414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2" y="6464151"/>
            <a:ext cx="4307046" cy="3414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EBE8AF-E450-476B-8A58-CE99446CAB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2363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EBE8AF-E450-476B-8A58-CE99446CABC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3138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22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440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66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881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102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32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542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763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9BB663-91F3-410C-92D7-8BB8937B89DA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46780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9B718-CB34-4C3A-8C5F-754C370C6848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4415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4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4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87CA8-1467-4047-9BFC-125E0E26BA6F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900522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22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440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66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881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102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32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542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763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127662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417740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8"/>
            <a:ext cx="5829300" cy="1816100"/>
          </a:xfrm>
        </p:spPr>
        <p:txBody>
          <a:bodyPr anchor="t"/>
          <a:lstStyle>
            <a:lvl1pPr algn="l">
              <a:defRPr sz="3692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50"/>
          </a:xfrm>
        </p:spPr>
        <p:txBody>
          <a:bodyPr anchor="b"/>
          <a:lstStyle>
            <a:lvl1pPr marL="0" indent="0">
              <a:buNone/>
              <a:defRPr sz="1846">
                <a:solidFill>
                  <a:schemeClr val="tx1">
                    <a:tint val="75000"/>
                  </a:schemeClr>
                </a:solidFill>
              </a:defRPr>
            </a:lvl1pPr>
            <a:lvl2pPr marL="422041" indent="0">
              <a:buNone/>
              <a:defRPr sz="1662">
                <a:solidFill>
                  <a:schemeClr val="tx1">
                    <a:tint val="75000"/>
                  </a:schemeClr>
                </a:solidFill>
              </a:defRPr>
            </a:lvl2pPr>
            <a:lvl3pPr marL="844083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3pPr>
            <a:lvl4pPr marL="1266124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4pPr>
            <a:lvl5pPr marL="1688165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5pPr>
            <a:lvl6pPr marL="2110207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6pPr>
            <a:lvl7pPr marL="2532248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7pPr>
            <a:lvl8pPr marL="2954289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8pPr>
            <a:lvl9pPr marL="3376331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4260050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283323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8"/>
            <a:ext cx="3031331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043177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7766713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747073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8"/>
            <a:ext cx="3833813" cy="7804151"/>
          </a:xfrm>
        </p:spPr>
        <p:txBody>
          <a:bodyPr/>
          <a:lstStyle>
            <a:lvl1pPr>
              <a:defRPr sz="2954"/>
            </a:lvl1pPr>
            <a:lvl2pPr>
              <a:defRPr sz="2585"/>
            </a:lvl2pPr>
            <a:lvl3pPr>
              <a:defRPr sz="2215"/>
            </a:lvl3pPr>
            <a:lvl4pPr>
              <a:defRPr sz="1846"/>
            </a:lvl4pPr>
            <a:lvl5pPr>
              <a:defRPr sz="1846"/>
            </a:lvl5pPr>
            <a:lvl6pPr>
              <a:defRPr sz="1846"/>
            </a:lvl6pPr>
            <a:lvl7pPr>
              <a:defRPr sz="1846"/>
            </a:lvl7pPr>
            <a:lvl8pPr>
              <a:defRPr sz="1846"/>
            </a:lvl8pPr>
            <a:lvl9pPr>
              <a:defRPr sz="1846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7"/>
            <a:ext cx="2256235" cy="6254751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7685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51DCA7-EAEC-4220-9160-308072BB10A0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901720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954"/>
            </a:lvl1pPr>
            <a:lvl2pPr marL="422041" indent="0">
              <a:buNone/>
              <a:defRPr sz="2585"/>
            </a:lvl2pPr>
            <a:lvl3pPr marL="844083" indent="0">
              <a:buNone/>
              <a:defRPr sz="2215"/>
            </a:lvl3pPr>
            <a:lvl4pPr marL="1266124" indent="0">
              <a:buNone/>
              <a:defRPr sz="1846"/>
            </a:lvl4pPr>
            <a:lvl5pPr marL="1688165" indent="0">
              <a:buNone/>
              <a:defRPr sz="1846"/>
            </a:lvl5pPr>
            <a:lvl6pPr marL="2110207" indent="0">
              <a:buNone/>
              <a:defRPr sz="1846"/>
            </a:lvl6pPr>
            <a:lvl7pPr marL="2532248" indent="0">
              <a:buNone/>
              <a:defRPr sz="1846"/>
            </a:lvl7pPr>
            <a:lvl8pPr marL="2954289" indent="0">
              <a:buNone/>
              <a:defRPr sz="1846"/>
            </a:lvl8pPr>
            <a:lvl9pPr marL="3376331" indent="0">
              <a:buNone/>
              <a:defRPr sz="1846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834158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369475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4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4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3777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8"/>
            <a:ext cx="5829300" cy="1816100"/>
          </a:xfrm>
        </p:spPr>
        <p:txBody>
          <a:bodyPr anchor="t"/>
          <a:lstStyle>
            <a:lvl1pPr algn="l">
              <a:defRPr sz="3692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50"/>
          </a:xfrm>
        </p:spPr>
        <p:txBody>
          <a:bodyPr anchor="b"/>
          <a:lstStyle>
            <a:lvl1pPr marL="0" indent="0">
              <a:buNone/>
              <a:defRPr sz="1846">
                <a:solidFill>
                  <a:schemeClr val="tx1">
                    <a:tint val="75000"/>
                  </a:schemeClr>
                </a:solidFill>
              </a:defRPr>
            </a:lvl1pPr>
            <a:lvl2pPr marL="422041" indent="0">
              <a:buNone/>
              <a:defRPr sz="1662">
                <a:solidFill>
                  <a:schemeClr val="tx1">
                    <a:tint val="75000"/>
                  </a:schemeClr>
                </a:solidFill>
              </a:defRPr>
            </a:lvl2pPr>
            <a:lvl3pPr marL="844083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3pPr>
            <a:lvl4pPr marL="1266124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4pPr>
            <a:lvl5pPr marL="1688165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5pPr>
            <a:lvl6pPr marL="2110207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6pPr>
            <a:lvl7pPr marL="2532248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7pPr>
            <a:lvl8pPr marL="2954289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8pPr>
            <a:lvl9pPr marL="3376331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6DBDD-9312-47FA-97BF-6C3830BB6F4E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2369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79C23-3E27-4090-9D76-00DFF340C5D8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8723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8"/>
            <a:ext cx="3031331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46D734-2941-4AC7-BB59-CEDD5974B69D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6785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86589-64FC-45C8-AE7D-5EEF0D6BCC01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6573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4946B-11D9-47C1-982E-B42319142936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79909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8"/>
            <a:ext cx="3833813" cy="7804151"/>
          </a:xfrm>
        </p:spPr>
        <p:txBody>
          <a:bodyPr/>
          <a:lstStyle>
            <a:lvl1pPr>
              <a:defRPr sz="2954"/>
            </a:lvl1pPr>
            <a:lvl2pPr>
              <a:defRPr sz="2585"/>
            </a:lvl2pPr>
            <a:lvl3pPr>
              <a:defRPr sz="2215"/>
            </a:lvl3pPr>
            <a:lvl4pPr>
              <a:defRPr sz="1846"/>
            </a:lvl4pPr>
            <a:lvl5pPr>
              <a:defRPr sz="1846"/>
            </a:lvl5pPr>
            <a:lvl6pPr>
              <a:defRPr sz="1846"/>
            </a:lvl6pPr>
            <a:lvl7pPr>
              <a:defRPr sz="1846"/>
            </a:lvl7pPr>
            <a:lvl8pPr>
              <a:defRPr sz="1846"/>
            </a:lvl8pPr>
            <a:lvl9pPr>
              <a:defRPr sz="1846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7"/>
            <a:ext cx="2256235" cy="6254751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927C-B8C0-4986-B4F3-80CB4AEE42DF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6007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954"/>
            </a:lvl1pPr>
            <a:lvl2pPr marL="422041" indent="0">
              <a:buNone/>
              <a:defRPr sz="2585"/>
            </a:lvl2pPr>
            <a:lvl3pPr marL="844083" indent="0">
              <a:buNone/>
              <a:defRPr sz="2215"/>
            </a:lvl3pPr>
            <a:lvl4pPr marL="1266124" indent="0">
              <a:buNone/>
              <a:defRPr sz="1846"/>
            </a:lvl4pPr>
            <a:lvl5pPr marL="1688165" indent="0">
              <a:buNone/>
              <a:defRPr sz="1846"/>
            </a:lvl5pPr>
            <a:lvl6pPr marL="2110207" indent="0">
              <a:buNone/>
              <a:defRPr sz="1846"/>
            </a:lvl6pPr>
            <a:lvl7pPr marL="2532248" indent="0">
              <a:buNone/>
              <a:defRPr sz="1846"/>
            </a:lvl7pPr>
            <a:lvl8pPr marL="2954289" indent="0">
              <a:buNone/>
              <a:defRPr sz="1846"/>
            </a:lvl8pPr>
            <a:lvl9pPr marL="3376331" indent="0">
              <a:buNone/>
              <a:defRPr sz="1846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2BB9-72A7-4C4B-B2E8-D9779D7C46D6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7373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1B968-4524-4380-A54A-DE3D743F0965}" type="datetime1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51862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sldNum="0" hdr="0" ftr="0" dt="0"/>
  <p:txStyles>
    <p:titleStyle>
      <a:lvl1pPr algn="ctr" defTabSz="844083" rtl="0" eaLnBrk="1" latinLnBrk="0" hangingPunct="1">
        <a:spcBef>
          <a:spcPct val="0"/>
        </a:spcBef>
        <a:buNone/>
        <a:defRPr kumimoji="1" sz="40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6531" indent="-31653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2954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63776" algn="l" defTabSz="844083" rtl="0" eaLnBrk="1" latinLnBrk="0" hangingPunct="1">
        <a:spcBef>
          <a:spcPct val="20000"/>
        </a:spcBef>
        <a:buFont typeface="Arial" pitchFamily="34" charset="0"/>
        <a:buChar char="–"/>
        <a:defRPr kumimoji="1" sz="2585" kern="1200">
          <a:solidFill>
            <a:schemeClr val="tx1"/>
          </a:solidFill>
          <a:latin typeface="+mn-lt"/>
          <a:ea typeface="+mn-ea"/>
          <a:cs typeface="+mn-cs"/>
        </a:defRPr>
      </a:lvl2pPr>
      <a:lvl3pPr marL="1055103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2215" kern="1200">
          <a:solidFill>
            <a:schemeClr val="tx1"/>
          </a:solidFill>
          <a:latin typeface="+mn-lt"/>
          <a:ea typeface="+mn-ea"/>
          <a:cs typeface="+mn-cs"/>
        </a:defRPr>
      </a:lvl3pPr>
      <a:lvl4pPr marL="1477145" indent="-211021" algn="l" defTabSz="844083" rtl="0" eaLnBrk="1" latinLnBrk="0" hangingPunct="1">
        <a:spcBef>
          <a:spcPct val="20000"/>
        </a:spcBef>
        <a:buFont typeface="Arial" pitchFamily="34" charset="0"/>
        <a:buChar char="–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4pPr>
      <a:lvl5pPr marL="1899186" indent="-211021" algn="l" defTabSz="844083" rtl="0" eaLnBrk="1" latinLnBrk="0" hangingPunct="1">
        <a:spcBef>
          <a:spcPct val="20000"/>
        </a:spcBef>
        <a:buFont typeface="Arial" pitchFamily="34" charset="0"/>
        <a:buChar char="»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5pPr>
      <a:lvl6pPr marL="2321227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7pPr>
      <a:lvl8pPr marL="3165310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8pPr>
      <a:lvl9pPr marL="3587351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1pPr>
      <a:lvl2pPr marL="422041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844083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3pPr>
      <a:lvl4pPr marL="1266124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4pPr>
      <a:lvl5pPr marL="1688165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5pPr>
      <a:lvl6pPr marL="2110207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6pPr>
      <a:lvl7pPr marL="2532248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7pPr>
      <a:lvl8pPr marL="2954289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8pPr>
      <a:lvl9pPr marL="3376331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5/11/30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0771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844083" rtl="0" eaLnBrk="1" latinLnBrk="0" hangingPunct="1">
        <a:spcBef>
          <a:spcPct val="0"/>
        </a:spcBef>
        <a:buNone/>
        <a:defRPr kumimoji="1" sz="40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6531" indent="-31653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2954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63776" algn="l" defTabSz="844083" rtl="0" eaLnBrk="1" latinLnBrk="0" hangingPunct="1">
        <a:spcBef>
          <a:spcPct val="20000"/>
        </a:spcBef>
        <a:buFont typeface="Arial" pitchFamily="34" charset="0"/>
        <a:buChar char="–"/>
        <a:defRPr kumimoji="1" sz="2585" kern="1200">
          <a:solidFill>
            <a:schemeClr val="tx1"/>
          </a:solidFill>
          <a:latin typeface="+mn-lt"/>
          <a:ea typeface="+mn-ea"/>
          <a:cs typeface="+mn-cs"/>
        </a:defRPr>
      </a:lvl2pPr>
      <a:lvl3pPr marL="1055103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2215" kern="1200">
          <a:solidFill>
            <a:schemeClr val="tx1"/>
          </a:solidFill>
          <a:latin typeface="+mn-lt"/>
          <a:ea typeface="+mn-ea"/>
          <a:cs typeface="+mn-cs"/>
        </a:defRPr>
      </a:lvl3pPr>
      <a:lvl4pPr marL="1477145" indent="-211021" algn="l" defTabSz="844083" rtl="0" eaLnBrk="1" latinLnBrk="0" hangingPunct="1">
        <a:spcBef>
          <a:spcPct val="20000"/>
        </a:spcBef>
        <a:buFont typeface="Arial" pitchFamily="34" charset="0"/>
        <a:buChar char="–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4pPr>
      <a:lvl5pPr marL="1899186" indent="-211021" algn="l" defTabSz="844083" rtl="0" eaLnBrk="1" latinLnBrk="0" hangingPunct="1">
        <a:spcBef>
          <a:spcPct val="20000"/>
        </a:spcBef>
        <a:buFont typeface="Arial" pitchFamily="34" charset="0"/>
        <a:buChar char="»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5pPr>
      <a:lvl6pPr marL="2321227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7pPr>
      <a:lvl8pPr marL="3165310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8pPr>
      <a:lvl9pPr marL="3587351" indent="-211021" algn="l" defTabSz="844083" rtl="0" eaLnBrk="1" latinLnBrk="0" hangingPunct="1">
        <a:spcBef>
          <a:spcPct val="20000"/>
        </a:spcBef>
        <a:buFont typeface="Arial" pitchFamily="34" charset="0"/>
        <a:buChar char="•"/>
        <a:defRPr kumimoji="1" sz="18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1pPr>
      <a:lvl2pPr marL="422041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844083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3pPr>
      <a:lvl4pPr marL="1266124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4pPr>
      <a:lvl5pPr marL="1688165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5pPr>
      <a:lvl6pPr marL="2110207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6pPr>
      <a:lvl7pPr marL="2532248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7pPr>
      <a:lvl8pPr marL="2954289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8pPr>
      <a:lvl9pPr marL="3376331" algn="l" defTabSz="844083" rtl="0" eaLnBrk="1" latinLnBrk="0" hangingPunct="1">
        <a:defRPr kumimoji="1" sz="16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73288" y="2863840"/>
            <a:ext cx="6111425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ja-JP" b="1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</a:t>
            </a:r>
            <a:r>
              <a:rPr lang="en-US" altLang="ja-JP" b="1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Materials</a:t>
            </a:r>
          </a:p>
          <a:p>
            <a:pPr algn="ctr">
              <a:spcAft>
                <a:spcPts val="0"/>
              </a:spcAft>
            </a:pPr>
            <a:endParaRPr lang="en-US" altLang="ja-JP" b="1" i="1" dirty="0" smtClean="0">
              <a:solidFill>
                <a:srgbClr val="000000"/>
              </a:solidFill>
              <a:latin typeface="Times New Roman" panose="02020603050405020304" pitchFamily="18" charset="0"/>
              <a:ea typeface="ヒラギノ角ゴ Pro W3"/>
            </a:endParaRPr>
          </a:p>
          <a:p>
            <a:pPr algn="ctr">
              <a:spcAft>
                <a:spcPts val="0"/>
              </a:spcAft>
            </a:pPr>
            <a:r>
              <a:rPr lang="en-US" altLang="ja-JP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Evasion 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of innate immune responses by the highly virulent </a:t>
            </a:r>
            <a:r>
              <a:rPr lang="en-US" altLang="ja-JP" b="1" dirty="0">
                <a:solidFill>
                  <a:srgbClr val="000000"/>
                </a:solidFill>
                <a:latin typeface="Times New Roman Italic" panose="02020503050405090304" pitchFamily="18" charset="0"/>
                <a:ea typeface="ヒラギノ角ゴ Pro W3"/>
                <a:cs typeface="Times New Roman" panose="02020603050405020304" pitchFamily="18" charset="0"/>
              </a:rPr>
              <a:t>Cryptococcus </a:t>
            </a:r>
            <a:r>
              <a:rPr lang="en-US" altLang="ja-JP" b="1" dirty="0" err="1">
                <a:solidFill>
                  <a:srgbClr val="000000"/>
                </a:solidFill>
                <a:latin typeface="Times New Roman Italic" panose="02020503050405090304" pitchFamily="18" charset="0"/>
                <a:ea typeface="ヒラギノ角ゴ Pro W3"/>
                <a:cs typeface="Times New Roman" panose="02020603050405020304" pitchFamily="18" charset="0"/>
              </a:rPr>
              <a:t>gattii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by altering capsule </a:t>
            </a:r>
            <a:r>
              <a:rPr lang="en-US" altLang="ja-JP" b="1" dirty="0" err="1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glucuronoxylomannan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</a:t>
            </a:r>
            <a:r>
              <a:rPr lang="en-US" altLang="ja-JP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structure</a:t>
            </a:r>
          </a:p>
          <a:p>
            <a:pPr algn="ctr">
              <a:spcAft>
                <a:spcPts val="0"/>
              </a:spcAft>
            </a:pPr>
            <a:endParaRPr lang="ja-JP" altLang="ja-JP" dirty="0">
              <a:solidFill>
                <a:srgbClr val="000000"/>
              </a:solidFill>
              <a:latin typeface="Times New Roman" panose="02020603050405020304" pitchFamily="18" charset="0"/>
              <a:ea typeface="ヒラギノ角ゴ Pro W3"/>
            </a:endParaRPr>
          </a:p>
          <a:p>
            <a:pPr>
              <a:spcAft>
                <a:spcPts val="0"/>
              </a:spcAft>
            </a:pP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Makoto Urai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1#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Yukihiro Kaneko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1,2#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Keigo Ueno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1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</a:t>
            </a:r>
            <a:r>
              <a:rPr lang="en-US" altLang="ja-JP" b="1" dirty="0" err="1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Yoichiro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Okubo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3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Tomoko Aizawa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4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Hidesuke Fukazawa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1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Takashi Sugita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5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Hideaki Ohno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1,6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</a:t>
            </a:r>
            <a:r>
              <a:rPr lang="en-US" altLang="ja-JP" b="1" dirty="0" err="1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Kazutoshi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Shibuya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3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Yuki Kinjo,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1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Yoshitsugu Miyazaki</a:t>
            </a:r>
            <a:r>
              <a:rPr lang="en-US" altLang="ja-JP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1</a:t>
            </a:r>
            <a:r>
              <a:rPr lang="en-US" altLang="ja-JP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*</a:t>
            </a:r>
          </a:p>
          <a:p>
            <a:pPr>
              <a:spcAft>
                <a:spcPts val="0"/>
              </a:spcAft>
            </a:pPr>
            <a:endParaRPr lang="ja-JP" altLang="ja-JP" dirty="0">
              <a:solidFill>
                <a:srgbClr val="000000"/>
              </a:solidFill>
              <a:latin typeface="Times New Roman" panose="02020603050405020304" pitchFamily="18" charset="0"/>
              <a:ea typeface="ヒラギノ角ゴ Pro W3"/>
            </a:endParaRPr>
          </a:p>
          <a:p>
            <a:r>
              <a:rPr lang="en-US" altLang="ja-JP" dirty="0">
                <a:latin typeface="Times New Roman" panose="02020603050405020304" pitchFamily="18" charset="0"/>
                <a:ea typeface="ヒラギノ角ゴ Pro W3"/>
              </a:rPr>
              <a:t>*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Correspondence: Yoshitsugu Miyazaki, ym46@niid.go.jp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915085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4863611"/>
              </p:ext>
            </p:extLst>
          </p:nvPr>
        </p:nvGraphicFramePr>
        <p:xfrm>
          <a:off x="349089" y="3040805"/>
          <a:ext cx="6158206" cy="1645920"/>
        </p:xfrm>
        <a:graphic>
          <a:graphicData uri="http://schemas.openxmlformats.org/drawingml/2006/table">
            <a:tbl>
              <a:tblPr firstRow="1" firstCol="1" bandRow="1"/>
              <a:tblGrid>
                <a:gridCol w="1024038"/>
                <a:gridCol w="2597523"/>
                <a:gridCol w="2536645"/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800" b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Strain</a:t>
                      </a:r>
                      <a:endParaRPr lang="ja-JP" sz="1800" b="1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800" b="1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in vivo </a:t>
                      </a:r>
                      <a:r>
                        <a:rPr lang="en-US" sz="1800" b="1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a</a:t>
                      </a:r>
                      <a:endParaRPr lang="ja-JP" sz="1800" b="1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800" b="1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in vitro </a:t>
                      </a:r>
                      <a:r>
                        <a:rPr lang="en-US" sz="1800" b="1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b</a:t>
                      </a:r>
                      <a:endParaRPr lang="ja-JP" sz="1800" b="1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H99</a:t>
                      </a:r>
                      <a:endParaRPr lang="ja-JP" sz="18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0.18 ± 0.01 mg/Lung</a:t>
                      </a:r>
                      <a:endParaRPr lang="ja-JP" sz="18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0.25 ± 0.03 mg/mL</a:t>
                      </a:r>
                      <a:endParaRPr lang="ja-JP" sz="18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JP02</a:t>
                      </a:r>
                      <a:endParaRPr lang="ja-JP" sz="180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1.62 ± 0.47 mg/Lung</a:t>
                      </a:r>
                      <a:endParaRPr lang="ja-JP" sz="18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0.28 ± 0.02 mg/mL</a:t>
                      </a:r>
                      <a:endParaRPr lang="ja-JP" sz="1800" dirty="0">
                        <a:effectLst/>
                        <a:latin typeface="Times New Roman" panose="02020603050405020304" pitchFamily="18" charset="0"/>
                        <a:ea typeface="ＭＳ 明朝" panose="02020609040205080304" pitchFamily="17" charset="-128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213861" y="4856846"/>
            <a:ext cx="6430279" cy="18158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ja-JP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a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EPSs were extracted from homogenates of murine lung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(n=3) as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described in Materials and Methods. Sugar content in the EPSs was measured by the phenol–H</a:t>
            </a:r>
            <a:r>
              <a:rPr lang="en-US" altLang="ja-JP" sz="16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2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SO</a:t>
            </a:r>
            <a:r>
              <a:rPr lang="en-US" altLang="ja-JP" sz="16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4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method using </a:t>
            </a:r>
            <a:r>
              <a:rPr lang="en-US" altLang="ja-JP" sz="11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D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-glucose as a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standard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(means ± standard deviations, SD). Data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were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compared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by unpaired </a:t>
            </a:r>
            <a:r>
              <a:rPr lang="en-US" altLang="ja-JP" sz="1600" i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t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-tests (</a:t>
            </a:r>
            <a:r>
              <a:rPr lang="en-US" altLang="ja-JP" sz="1600" i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P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&lt; 0.01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).</a:t>
            </a:r>
            <a:endParaRPr lang="ja-JP" altLang="ja-JP" sz="1600" dirty="0">
              <a:solidFill>
                <a:srgbClr val="000000"/>
              </a:solidFill>
              <a:latin typeface="Times New Roman" panose="02020603050405020304" pitchFamily="18" charset="0"/>
              <a:ea typeface="ヒラギノ角ゴ Pro W3"/>
            </a:endParaRPr>
          </a:p>
          <a:p>
            <a:r>
              <a:rPr lang="en-US" altLang="ja-JP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b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EPSs were extracted from culture medium as described in Materials and Methods. The</a:t>
            </a:r>
            <a:r>
              <a:rPr lang="ja-JP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experiments were performed in triplicate (means ±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SD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).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Data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were compared by the unpaired </a:t>
            </a:r>
            <a:r>
              <a:rPr lang="en-US" altLang="ja-JP" sz="1600" i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t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-test (</a:t>
            </a:r>
            <a:r>
              <a:rPr lang="en-US" altLang="ja-JP" sz="1600" i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P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&gt; 0.01). </a:t>
            </a:r>
            <a:endParaRPr kumimoji="0" lang="en-US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52706" y="2212230"/>
            <a:ext cx="6352588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Table S1. Amounts of secreted extracellular polysaccharides </a:t>
            </a:r>
            <a:r>
              <a:rPr lang="en-US" altLang="ja-JP" b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(</a:t>
            </a:r>
            <a:r>
              <a:rPr lang="en-US" altLang="ja-JP" dirty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EPS</a:t>
            </a:r>
            <a:r>
              <a:rPr lang="en-US" altLang="ja-JP" b="1" dirty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)</a:t>
            </a:r>
            <a:r>
              <a:rPr lang="en-US" altLang="ja-JP" dirty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from H99 and JP02 </a:t>
            </a:r>
            <a:r>
              <a:rPr lang="en-US" altLang="ja-JP" i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in vivo</a:t>
            </a:r>
            <a:r>
              <a:rPr lang="en-US" altLang="ja-JP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and </a:t>
            </a:r>
            <a:r>
              <a:rPr lang="en-US" altLang="ja-JP" i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in vitro</a:t>
            </a:r>
            <a:endParaRPr kumimoji="0" lang="en-US" altLang="ja-JP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6185024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テキスト ボックス 36"/>
          <p:cNvSpPr txBox="1"/>
          <p:nvPr/>
        </p:nvSpPr>
        <p:spPr>
          <a:xfrm>
            <a:off x="196691" y="177706"/>
            <a:ext cx="458780" cy="5469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954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2954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07693" y="4317840"/>
            <a:ext cx="437940" cy="5469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954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sz="2954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 rot="16200000">
            <a:off x="714316" y="5641588"/>
            <a:ext cx="1981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4+ cells (%)</a:t>
            </a:r>
            <a:endParaRPr lang="en-US" altLang="ja-JP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5" name="グラフ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4824261"/>
              </p:ext>
            </p:extLst>
          </p:nvPr>
        </p:nvGraphicFramePr>
        <p:xfrm>
          <a:off x="1833747" y="4451055"/>
          <a:ext cx="4645152" cy="3222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6" name="テキスト ボックス 35"/>
          <p:cNvSpPr txBox="1"/>
          <p:nvPr/>
        </p:nvSpPr>
        <p:spPr>
          <a:xfrm>
            <a:off x="2486172" y="7543342"/>
            <a:ext cx="3299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ys after first administration</a:t>
            </a:r>
            <a:endParaRPr lang="en-US" altLang="ja-JP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23093" y="7913314"/>
            <a:ext cx="661181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Confirmation of CD4+ cells depletion by flow cytometry analysis.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were injected intraperitoneally with 300 µg monoclonal anti-CD4 antibody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antibody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ay 0) an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100 µg o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after the first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ministratio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ay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) 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od was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d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orbita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us of mice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6, 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6, and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, and the percentage of CD4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R</a:t>
            </a:r>
            <a:r>
              <a:rPr lang="en-US" altLang="ja-JP" sz="1200" dirty="0" err="1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among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CR</a:t>
            </a:r>
            <a:r>
              <a:rPr lang="en-US" altLang="ja-JP" sz="1200" dirty="0" err="1" smtClean="0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ymphocytes  in blood was analyzed by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. Representative flow cytometry profiles (A) and time-dependent changes of the percentage of CD4+ cells (B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re shown. 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93" b="13826"/>
          <a:stretch/>
        </p:blipFill>
        <p:spPr bwMode="auto">
          <a:xfrm>
            <a:off x="939713" y="896669"/>
            <a:ext cx="1523162" cy="15926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15" b="14248"/>
          <a:stretch/>
        </p:blipFill>
        <p:spPr bwMode="auto">
          <a:xfrm>
            <a:off x="939713" y="2359552"/>
            <a:ext cx="1533402" cy="15848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テキスト ボックス 25"/>
          <p:cNvSpPr txBox="1"/>
          <p:nvPr/>
        </p:nvSpPr>
        <p:spPr>
          <a:xfrm>
            <a:off x="1059360" y="3944115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Rβ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 rot="16200000">
            <a:off x="401269" y="3283706"/>
            <a:ext cx="8108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130695" y="2578985"/>
            <a:ext cx="57087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2.0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133634" y="1114073"/>
            <a:ext cx="567934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7.5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67" t="-246" r="188" b="14168"/>
          <a:stretch/>
        </p:blipFill>
        <p:spPr bwMode="auto">
          <a:xfrm>
            <a:off x="2378518" y="895764"/>
            <a:ext cx="1509664" cy="1590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7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93" b="13376"/>
          <a:stretch/>
        </p:blipFill>
        <p:spPr bwMode="auto">
          <a:xfrm>
            <a:off x="2378518" y="2358648"/>
            <a:ext cx="1512543" cy="16009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テキスト ボックス 14"/>
          <p:cNvSpPr txBox="1"/>
          <p:nvPr/>
        </p:nvSpPr>
        <p:spPr>
          <a:xfrm>
            <a:off x="2553501" y="2569299"/>
            <a:ext cx="5460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13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553501" y="1114073"/>
            <a:ext cx="5460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.8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89" b="13815"/>
          <a:stretch/>
        </p:blipFill>
        <p:spPr bwMode="auto">
          <a:xfrm>
            <a:off x="3796463" y="895019"/>
            <a:ext cx="1526780" cy="15928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" name="Picture 4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89" b="13704"/>
          <a:stretch/>
        </p:blipFill>
        <p:spPr bwMode="auto">
          <a:xfrm>
            <a:off x="3796463" y="2359715"/>
            <a:ext cx="1526780" cy="15949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テキスト ボックス 19"/>
          <p:cNvSpPr txBox="1"/>
          <p:nvPr/>
        </p:nvSpPr>
        <p:spPr>
          <a:xfrm>
            <a:off x="3983808" y="1114073"/>
            <a:ext cx="5460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1.0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3983808" y="2571758"/>
            <a:ext cx="5460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45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943457" y="453877"/>
            <a:ext cx="15183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fore </a:t>
            </a:r>
          </a:p>
          <a:p>
            <a:pPr algn="ctr"/>
            <a:r>
              <a:rPr lang="en-US" altLang="ja-JP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ministration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808475" y="703196"/>
            <a:ext cx="859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 2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196007" y="686353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1"/>
          <p:cNvSpPr txBox="1"/>
          <p:nvPr/>
        </p:nvSpPr>
        <p:spPr>
          <a:xfrm rot="16200000">
            <a:off x="-229940" y="3008407"/>
            <a:ext cx="1196297" cy="300878"/>
          </a:xfrm>
          <a:prstGeom prst="rect">
            <a:avLst/>
          </a:prstGeom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-CD4 IgG</a:t>
            </a:r>
            <a:endParaRPr lang="ja-JP" altLang="en-US" sz="18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1"/>
          <p:cNvSpPr txBox="1"/>
          <p:nvPr/>
        </p:nvSpPr>
        <p:spPr>
          <a:xfrm rot="16200000">
            <a:off x="-145916" y="1504192"/>
            <a:ext cx="1028249" cy="300878"/>
          </a:xfrm>
          <a:prstGeom prst="rect">
            <a:avLst/>
          </a:prstGeom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8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IgG</a:t>
            </a:r>
            <a:endParaRPr lang="ja-JP" altLang="en-US" sz="18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579167" y="703196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5" name="図 4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35966" y="1052950"/>
            <a:ext cx="1420866" cy="1390249"/>
          </a:xfrm>
          <a:prstGeom prst="rect">
            <a:avLst/>
          </a:prstGeom>
        </p:spPr>
      </p:pic>
      <p:pic>
        <p:nvPicPr>
          <p:cNvPr id="46" name="図 4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54554" y="2524033"/>
            <a:ext cx="1379482" cy="1349757"/>
          </a:xfrm>
          <a:prstGeom prst="rect">
            <a:avLst/>
          </a:prstGeom>
        </p:spPr>
      </p:pic>
      <p:sp>
        <p:nvSpPr>
          <p:cNvPr id="47" name="テキスト ボックス 46"/>
          <p:cNvSpPr txBox="1"/>
          <p:nvPr/>
        </p:nvSpPr>
        <p:spPr>
          <a:xfrm>
            <a:off x="5479693" y="2602469"/>
            <a:ext cx="5460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43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418869" y="1123662"/>
            <a:ext cx="5460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1.0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矢印コネクタ 3"/>
          <p:cNvCxnSpPr/>
          <p:nvPr/>
        </p:nvCxnSpPr>
        <p:spPr>
          <a:xfrm flipV="1">
            <a:off x="806686" y="1100208"/>
            <a:ext cx="0" cy="2098704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  <a:effectLst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線矢印コネクタ 6"/>
          <p:cNvCxnSpPr/>
          <p:nvPr/>
        </p:nvCxnSpPr>
        <p:spPr>
          <a:xfrm>
            <a:off x="1876783" y="4128836"/>
            <a:ext cx="4560311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293992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0190455"/>
              </p:ext>
            </p:extLst>
          </p:nvPr>
        </p:nvGraphicFramePr>
        <p:xfrm>
          <a:off x="1767277" y="1593509"/>
          <a:ext cx="3860258" cy="45198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796787" y="2856419"/>
            <a:ext cx="1162737" cy="660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46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-6</a:t>
            </a:r>
          </a:p>
          <a:p>
            <a:pPr algn="ctr"/>
            <a:r>
              <a:rPr lang="en-US" altLang="ja-JP" sz="1846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[pg/ml]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53234" y="5859627"/>
            <a:ext cx="6351533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Fig.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S2. </a:t>
            </a:r>
            <a:r>
              <a:rPr lang="en-US" altLang="ja-JP" sz="1600" dirty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Effect of </a:t>
            </a:r>
            <a:r>
              <a:rPr lang="en-US" altLang="ja-JP" sz="1600" dirty="0" err="1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polymyxin</a:t>
            </a:r>
            <a:r>
              <a:rPr lang="en-US" altLang="ja-JP" sz="1600" dirty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 B on IL-6 release from JAWSII cells in response to EPS fractions from H99 and JP02 strains.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JAWSII cells (2 × 10</a:t>
            </a:r>
            <a:r>
              <a:rPr lang="en-US" altLang="ja-JP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5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cells/mL) were incubated with EPS (50 </a:t>
            </a:r>
            <a:r>
              <a:rPr lang="en-US" altLang="ja-JP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μg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/mL) and </a:t>
            </a:r>
            <a:r>
              <a:rPr lang="en-US" altLang="ja-JP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polymyxin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B (100 </a:t>
            </a:r>
            <a:r>
              <a:rPr lang="en-US" altLang="ja-JP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μg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/mL) for 24 h, and the supernatant was obtained for ELISA. The</a:t>
            </a:r>
            <a:r>
              <a:rPr lang="ja-JP" alt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experiments were performed in triplicate (means ± SD).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Data 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were compared by the unpaired </a:t>
            </a:r>
            <a:r>
              <a:rPr lang="en-US" altLang="ja-JP" sz="1600" i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t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-test, except for vs. PB</a:t>
            </a:r>
            <a:r>
              <a:rPr lang="en-US" altLang="ja-JP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-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control, which were compared by the Mann–Whitney U-test (*, </a:t>
            </a:r>
            <a:r>
              <a:rPr lang="en-US" altLang="ja-JP" sz="1600" i="1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P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&lt; 0.01; NS, not significant). 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右中かっこ 19"/>
          <p:cNvSpPr/>
          <p:nvPr/>
        </p:nvSpPr>
        <p:spPr>
          <a:xfrm rot="16200000">
            <a:off x="3050322" y="1883941"/>
            <a:ext cx="45719" cy="284588"/>
          </a:xfrm>
          <a:custGeom>
            <a:avLst/>
            <a:gdLst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1044116 w 2088232"/>
              <a:gd name="connsiteY3" fmla="*/ 602017 h 1204011"/>
              <a:gd name="connsiteX4" fmla="*/ 1044116 w 2088232"/>
              <a:gd name="connsiteY4" fmla="*/ 1203999 h 1204011"/>
              <a:gd name="connsiteX5" fmla="*/ 0 w 2088232"/>
              <a:gd name="connsiteY5" fmla="*/ 1204011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  <a:gd name="connsiteX6" fmla="*/ 0 w 1044116"/>
              <a:gd name="connsiteY6" fmla="*/ 0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4116" h="1204011" stroke="0" extrusionOk="0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  <a:lnTo>
                  <a:pt x="0" y="0"/>
                </a:lnTo>
                <a:close/>
              </a:path>
              <a:path w="1044116" h="1204011" fill="none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</a:path>
            </a:pathLst>
          </a:custGeom>
          <a:ln w="1905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49868" y="1456705"/>
            <a:ext cx="29046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62" dirty="0"/>
              <a:t>*</a:t>
            </a:r>
            <a:endParaRPr lang="ja-JP" altLang="en-US" sz="1662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536105" y="1445461"/>
            <a:ext cx="29046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62" dirty="0"/>
              <a:t>*</a:t>
            </a:r>
            <a:endParaRPr lang="ja-JP" altLang="en-US" sz="1662" dirty="0"/>
          </a:p>
        </p:txBody>
      </p:sp>
      <p:sp>
        <p:nvSpPr>
          <p:cNvPr id="14" name="右中かっこ 19"/>
          <p:cNvSpPr/>
          <p:nvPr/>
        </p:nvSpPr>
        <p:spPr>
          <a:xfrm rot="16200000">
            <a:off x="3648452" y="1244782"/>
            <a:ext cx="48963" cy="903194"/>
          </a:xfrm>
          <a:custGeom>
            <a:avLst/>
            <a:gdLst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1044116 w 2088232"/>
              <a:gd name="connsiteY3" fmla="*/ 602017 h 1204011"/>
              <a:gd name="connsiteX4" fmla="*/ 1044116 w 2088232"/>
              <a:gd name="connsiteY4" fmla="*/ 1203999 h 1204011"/>
              <a:gd name="connsiteX5" fmla="*/ 0 w 2088232"/>
              <a:gd name="connsiteY5" fmla="*/ 1204011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  <a:gd name="connsiteX6" fmla="*/ 0 w 1044116"/>
              <a:gd name="connsiteY6" fmla="*/ 0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4116" h="1204011" stroke="0" extrusionOk="0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  <a:lnTo>
                  <a:pt x="0" y="0"/>
                </a:lnTo>
                <a:close/>
              </a:path>
              <a:path w="1044116" h="1204011" fill="none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</a:path>
            </a:pathLst>
          </a:custGeom>
          <a:ln w="1905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18" name="右中かっこ 19"/>
          <p:cNvSpPr/>
          <p:nvPr/>
        </p:nvSpPr>
        <p:spPr>
          <a:xfrm rot="16200000">
            <a:off x="5001377" y="1892816"/>
            <a:ext cx="45719" cy="284588"/>
          </a:xfrm>
          <a:custGeom>
            <a:avLst/>
            <a:gdLst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1044116 w 2088232"/>
              <a:gd name="connsiteY3" fmla="*/ 602017 h 1204011"/>
              <a:gd name="connsiteX4" fmla="*/ 1044116 w 2088232"/>
              <a:gd name="connsiteY4" fmla="*/ 1203999 h 1204011"/>
              <a:gd name="connsiteX5" fmla="*/ 0 w 2088232"/>
              <a:gd name="connsiteY5" fmla="*/ 1204011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  <a:gd name="connsiteX6" fmla="*/ 0 w 1044116"/>
              <a:gd name="connsiteY6" fmla="*/ 0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4116" h="1204011" stroke="0" extrusionOk="0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  <a:lnTo>
                  <a:pt x="0" y="0"/>
                </a:lnTo>
                <a:close/>
              </a:path>
              <a:path w="1044116" h="1204011" fill="none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</a:path>
            </a:pathLst>
          </a:custGeom>
          <a:ln w="1905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20" name="右中かっこ 19"/>
          <p:cNvSpPr/>
          <p:nvPr/>
        </p:nvSpPr>
        <p:spPr>
          <a:xfrm rot="16200000">
            <a:off x="4035060" y="1897334"/>
            <a:ext cx="45719" cy="284588"/>
          </a:xfrm>
          <a:custGeom>
            <a:avLst/>
            <a:gdLst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1044116 w 2088232"/>
              <a:gd name="connsiteY3" fmla="*/ 602017 h 1204011"/>
              <a:gd name="connsiteX4" fmla="*/ 1044116 w 2088232"/>
              <a:gd name="connsiteY4" fmla="*/ 1203999 h 1204011"/>
              <a:gd name="connsiteX5" fmla="*/ 0 w 2088232"/>
              <a:gd name="connsiteY5" fmla="*/ 1204011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  <a:gd name="connsiteX6" fmla="*/ 0 w 1044116"/>
              <a:gd name="connsiteY6" fmla="*/ 0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4116" h="1204011" stroke="0" extrusionOk="0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  <a:lnTo>
                  <a:pt x="0" y="0"/>
                </a:lnTo>
                <a:close/>
              </a:path>
              <a:path w="1044116" h="1204011" fill="none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</a:path>
            </a:pathLst>
          </a:custGeom>
          <a:ln w="1905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22" name="右中かっこ 19"/>
          <p:cNvSpPr/>
          <p:nvPr/>
        </p:nvSpPr>
        <p:spPr>
          <a:xfrm rot="16200000">
            <a:off x="4673640" y="1226346"/>
            <a:ext cx="45719" cy="940066"/>
          </a:xfrm>
          <a:custGeom>
            <a:avLst/>
            <a:gdLst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1044116 w 2088232"/>
              <a:gd name="connsiteY3" fmla="*/ 602017 h 1204011"/>
              <a:gd name="connsiteX4" fmla="*/ 1044116 w 2088232"/>
              <a:gd name="connsiteY4" fmla="*/ 1203999 h 1204011"/>
              <a:gd name="connsiteX5" fmla="*/ 0 w 2088232"/>
              <a:gd name="connsiteY5" fmla="*/ 1204011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  <a:gd name="connsiteX6" fmla="*/ 0 w 1044116"/>
              <a:gd name="connsiteY6" fmla="*/ 0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4116" h="1204011" stroke="0" extrusionOk="0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  <a:lnTo>
                  <a:pt x="0" y="0"/>
                </a:lnTo>
                <a:close/>
              </a:path>
              <a:path w="1044116" h="1204011" fill="none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</a:path>
            </a:pathLst>
          </a:custGeom>
          <a:ln w="1905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295601" y="1181211"/>
            <a:ext cx="29046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62" dirty="0"/>
              <a:t>*</a:t>
            </a:r>
            <a:endParaRPr lang="ja-JP" altLang="en-US" sz="1662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4252654" y="1179695"/>
            <a:ext cx="29046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62" dirty="0"/>
              <a:t>*</a:t>
            </a:r>
            <a:endParaRPr lang="ja-JP" altLang="en-US" sz="1662" dirty="0"/>
          </a:p>
        </p:txBody>
      </p:sp>
      <p:sp>
        <p:nvSpPr>
          <p:cNvPr id="25" name="右中かっこ 19"/>
          <p:cNvSpPr/>
          <p:nvPr/>
        </p:nvSpPr>
        <p:spPr>
          <a:xfrm rot="16200000">
            <a:off x="3361339" y="956644"/>
            <a:ext cx="68004" cy="928900"/>
          </a:xfrm>
          <a:custGeom>
            <a:avLst/>
            <a:gdLst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1044116 w 2088232"/>
              <a:gd name="connsiteY3" fmla="*/ 602017 h 1204011"/>
              <a:gd name="connsiteX4" fmla="*/ 1044116 w 2088232"/>
              <a:gd name="connsiteY4" fmla="*/ 1203999 h 1204011"/>
              <a:gd name="connsiteX5" fmla="*/ 0 w 2088232"/>
              <a:gd name="connsiteY5" fmla="*/ 1204011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  <a:gd name="connsiteX6" fmla="*/ 0 w 1044116"/>
              <a:gd name="connsiteY6" fmla="*/ 0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4116" h="1204011" stroke="0" extrusionOk="0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  <a:lnTo>
                  <a:pt x="0" y="0"/>
                </a:lnTo>
                <a:close/>
              </a:path>
              <a:path w="1044116" h="1204011" fill="none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</a:path>
            </a:pathLst>
          </a:custGeom>
          <a:ln w="1905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26" name="右中かっこ 19"/>
          <p:cNvSpPr/>
          <p:nvPr/>
        </p:nvSpPr>
        <p:spPr>
          <a:xfrm rot="16200000">
            <a:off x="4364413" y="945670"/>
            <a:ext cx="76107" cy="958952"/>
          </a:xfrm>
          <a:custGeom>
            <a:avLst/>
            <a:gdLst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2088232 w 2088232"/>
              <a:gd name="connsiteY3" fmla="*/ 602005 h 1204011"/>
              <a:gd name="connsiteX4" fmla="*/ 1044116 w 2088232"/>
              <a:gd name="connsiteY4" fmla="*/ 602017 h 1204011"/>
              <a:gd name="connsiteX5" fmla="*/ 1044116 w 2088232"/>
              <a:gd name="connsiteY5" fmla="*/ 1203999 h 1204011"/>
              <a:gd name="connsiteX6" fmla="*/ 0 w 2088232"/>
              <a:gd name="connsiteY6" fmla="*/ 1204011 h 1204011"/>
              <a:gd name="connsiteX7" fmla="*/ 0 w 2088232"/>
              <a:gd name="connsiteY7" fmla="*/ 0 h 1204011"/>
              <a:gd name="connsiteX0" fmla="*/ 0 w 2088232"/>
              <a:gd name="connsiteY0" fmla="*/ 0 h 1204011"/>
              <a:gd name="connsiteX1" fmla="*/ 1044116 w 2088232"/>
              <a:gd name="connsiteY1" fmla="*/ 12 h 1204011"/>
              <a:gd name="connsiteX2" fmla="*/ 1044116 w 2088232"/>
              <a:gd name="connsiteY2" fmla="*/ 601993 h 1204011"/>
              <a:gd name="connsiteX3" fmla="*/ 1044116 w 2088232"/>
              <a:gd name="connsiteY3" fmla="*/ 602017 h 1204011"/>
              <a:gd name="connsiteX4" fmla="*/ 1044116 w 2088232"/>
              <a:gd name="connsiteY4" fmla="*/ 1203999 h 1204011"/>
              <a:gd name="connsiteX5" fmla="*/ 0 w 2088232"/>
              <a:gd name="connsiteY5" fmla="*/ 1204011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  <a:gd name="connsiteX6" fmla="*/ 0 w 1044116"/>
              <a:gd name="connsiteY6" fmla="*/ 0 h 1204011"/>
              <a:gd name="connsiteX0" fmla="*/ 0 w 1044116"/>
              <a:gd name="connsiteY0" fmla="*/ 0 h 1204011"/>
              <a:gd name="connsiteX1" fmla="*/ 1044116 w 1044116"/>
              <a:gd name="connsiteY1" fmla="*/ 12 h 1204011"/>
              <a:gd name="connsiteX2" fmla="*/ 1044116 w 1044116"/>
              <a:gd name="connsiteY2" fmla="*/ 601993 h 1204011"/>
              <a:gd name="connsiteX3" fmla="*/ 1044116 w 1044116"/>
              <a:gd name="connsiteY3" fmla="*/ 602017 h 1204011"/>
              <a:gd name="connsiteX4" fmla="*/ 1044116 w 1044116"/>
              <a:gd name="connsiteY4" fmla="*/ 1203999 h 1204011"/>
              <a:gd name="connsiteX5" fmla="*/ 0 w 1044116"/>
              <a:gd name="connsiteY5" fmla="*/ 1204011 h 12040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4116" h="1204011" stroke="0" extrusionOk="0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  <a:lnTo>
                  <a:pt x="0" y="0"/>
                </a:lnTo>
                <a:close/>
              </a:path>
              <a:path w="1044116" h="1204011" fill="none">
                <a:moveTo>
                  <a:pt x="0" y="0"/>
                </a:moveTo>
                <a:lnTo>
                  <a:pt x="1044116" y="12"/>
                </a:lnTo>
                <a:lnTo>
                  <a:pt x="1044116" y="601993"/>
                </a:lnTo>
                <a:lnTo>
                  <a:pt x="1044116" y="602017"/>
                </a:lnTo>
                <a:lnTo>
                  <a:pt x="1044116" y="1203999"/>
                </a:lnTo>
                <a:cubicBezTo>
                  <a:pt x="1044116" y="1204006"/>
                  <a:pt x="576649" y="1204011"/>
                  <a:pt x="0" y="1204011"/>
                </a:cubicBezTo>
              </a:path>
            </a:pathLst>
          </a:custGeom>
          <a:ln w="19050" cap="sq">
            <a:solidFill>
              <a:schemeClr val="tx1"/>
            </a:solidFill>
            <a:miter lim="800000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866233" y="1704473"/>
            <a:ext cx="413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859522" y="1706671"/>
            <a:ext cx="413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804643" y="1704473"/>
            <a:ext cx="413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58436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686" y="4254762"/>
            <a:ext cx="5471613" cy="2720824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686" y="1443299"/>
            <a:ext cx="5471613" cy="2765739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1969396" y="2495764"/>
            <a:ext cx="73770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846" b="1" dirty="0" err="1">
                <a:solidFill>
                  <a:prstClr val="black"/>
                </a:solidFill>
                <a:latin typeface="Arial" charset="0"/>
              </a:rPr>
              <a:t>GlcA</a:t>
            </a:r>
            <a:endParaRPr lang="ja-JP" altLang="en-US" sz="1846" b="1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760786" y="1634148"/>
            <a:ext cx="65755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846" b="1" dirty="0">
                <a:solidFill>
                  <a:prstClr val="black"/>
                </a:solidFill>
                <a:latin typeface="Arial" charset="0"/>
              </a:rPr>
              <a:t>Man</a:t>
            </a:r>
            <a:endParaRPr lang="ja-JP" altLang="en-US" sz="1846" b="1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488978" y="2051546"/>
            <a:ext cx="540533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846" b="1" dirty="0" err="1">
                <a:solidFill>
                  <a:prstClr val="black"/>
                </a:solidFill>
                <a:latin typeface="Arial" charset="0"/>
              </a:rPr>
              <a:t>Xyl</a:t>
            </a:r>
            <a:endParaRPr lang="ja-JP" altLang="en-US" sz="1846" b="1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969396" y="5238773"/>
            <a:ext cx="73770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846" b="1" dirty="0" err="1">
                <a:solidFill>
                  <a:prstClr val="black"/>
                </a:solidFill>
                <a:latin typeface="Arial" charset="0"/>
              </a:rPr>
              <a:t>GlcA</a:t>
            </a:r>
            <a:endParaRPr lang="ja-JP" altLang="en-US" sz="1846" b="1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760786" y="4448481"/>
            <a:ext cx="657552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846" b="1" dirty="0">
                <a:solidFill>
                  <a:prstClr val="black"/>
                </a:solidFill>
                <a:latin typeface="Arial" charset="0"/>
              </a:rPr>
              <a:t>Man</a:t>
            </a:r>
            <a:endParaRPr lang="ja-JP" altLang="en-US" sz="1846" b="1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488978" y="4419000"/>
            <a:ext cx="540533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846" b="1" dirty="0" err="1">
                <a:solidFill>
                  <a:prstClr val="black"/>
                </a:solidFill>
                <a:latin typeface="Arial" charset="0"/>
              </a:rPr>
              <a:t>Xyl</a:t>
            </a:r>
            <a:endParaRPr lang="ja-JP" altLang="en-US" sz="1846" b="1" dirty="0">
              <a:solidFill>
                <a:prstClr val="black"/>
              </a:solidFill>
              <a:latin typeface="Arial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07244" y="1263661"/>
            <a:ext cx="458780" cy="5469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954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2954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18246" y="4047315"/>
            <a:ext cx="437940" cy="5469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954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sz="2954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87171" y="7501811"/>
            <a:ext cx="62836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Fig. </a:t>
            </a:r>
            <a:r>
              <a:rPr lang="en-US" altLang="ja-JP" sz="1600" dirty="0" smtClean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S3. </a:t>
            </a:r>
            <a:r>
              <a:rPr lang="en-US" altLang="ja-JP" sz="1600" dirty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HPLC profiles of ABEE-labeled </a:t>
            </a:r>
            <a:r>
              <a:rPr lang="en-US" altLang="ja-JP" sz="1600" dirty="0" err="1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hydrolysate</a:t>
            </a:r>
            <a:r>
              <a:rPr lang="en-US" altLang="ja-JP" sz="1600" dirty="0">
                <a:solidFill>
                  <a:srgbClr val="000000"/>
                </a:solidFill>
                <a:latin typeface="Times New Roman Bold" panose="02020803070505020304" pitchFamily="18" charset="0"/>
                <a:ea typeface="ヒラギノ角ゴ Pro W3"/>
                <a:cs typeface="Times New Roman" panose="02020603050405020304" pitchFamily="18" charset="0"/>
              </a:rPr>
              <a:t> of GXM purified from H99 and JP02 strain.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ヒラギノ角ゴ Pro W3"/>
              </a:rPr>
              <a:t> A, H99 and B, JP02.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166114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04&quot;&gt;&lt;property id=&quot;20148&quot; value=&quot;5&quot;/&gt;&lt;property id=&quot;20300&quot; value=&quot;スライド 1&quot;/&gt;&lt;property id=&quot;20307&quot; value=&quot;269&quot;/&gt;&lt;/object&gt;&lt;object type=&quot;3&quot; unique_id=&quot;10005&quot;&gt;&lt;property id=&quot;20148&quot; value=&quot;5&quot;/&gt;&lt;property id=&quot;20300&quot; value=&quot;スライド 2&quot;/&gt;&lt;property id=&quot;20307&quot; value=&quot;270&quot;/&gt;&lt;/object&gt;&lt;object type=&quot;3&quot; unique_id=&quot;10006&quot;&gt;&lt;property id=&quot;20148&quot; value=&quot;5&quot;/&gt;&lt;property id=&quot;20300&quot; value=&quot;スライド 3&quot;/&gt;&lt;property id=&quot;20307&quot; value=&quot;271&quot;/&gt;&lt;/object&gt;&lt;object type=&quot;3&quot; unique_id=&quot;10007&quot;&gt;&lt;property id=&quot;20148&quot; value=&quot;5&quot;/&gt;&lt;property id=&quot;20300&quot; value=&quot;スライド 4&quot;/&gt;&lt;property id=&quot;20307&quot; value=&quot;267&quot;/&gt;&lt;/object&gt;&lt;object type=&quot;3&quot; unique_id=&quot;10008&quot;&gt;&lt;property id=&quot;20148&quot; value=&quot;5&quot;/&gt;&lt;property id=&quot;20300&quot; value=&quot;スライド 5&quot;/&gt;&lt;property id=&quot;20307&quot; value=&quot;268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2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DB081F1630DF044A89A162899993427" ma:contentTypeVersion="7" ma:contentTypeDescription="Create a new document." ma:contentTypeScope="" ma:versionID="4460264a3dc2930b8dae4c2040637feb">
  <xsd:schema xmlns:xsd="http://www.w3.org/2001/XMLSchema" xmlns:p="http://schemas.microsoft.com/office/2006/metadata/properties" xmlns:ns2="42e662fb-3aab-4e05-8c92-e0cc04822673" targetNamespace="http://schemas.microsoft.com/office/2006/metadata/properties" ma:root="true" ma:fieldsID="c005207c720682cbd62930cf147b2d99" ns2:_="">
    <xsd:import namespace="42e662fb-3aab-4e05-8c92-e0cc0482267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2e662fb-3aab-4e05-8c92-e0cc0482267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42e662fb-3aab-4e05-8c92-e0cc04822673" xsi:nil="true"/>
    <FileFormat xmlns="42e662fb-3aab-4e05-8c92-e0cc04822673">PPTX</FileFormat>
    <DocumentId xmlns="42e662fb-3aab-4e05-8c92-e0cc04822673">Presentation 1.PPTX</DocumentId>
    <IsDeleted xmlns="42e662fb-3aab-4e05-8c92-e0cc04822673">false</IsDeleted>
    <Checked_x0020_Out_x0020_To xmlns="42e662fb-3aab-4e05-8c92-e0cc04822673">
      <UserInfo>
        <DisplayName/>
        <AccountId xsi:nil="true"/>
        <AccountType/>
      </UserInfo>
    </Checked_x0020_Out_x0020_To>
    <TitleName xmlns="42e662fb-3aab-4e05-8c92-e0cc04822673">Presentation 1.PPTX</TitleName>
    <DocumentType xmlns="42e662fb-3aab-4e05-8c92-e0cc04822673">Presentation</DocumentType>
  </documentManagement>
</p:properties>
</file>

<file path=customXml/itemProps1.xml><?xml version="1.0" encoding="utf-8"?>
<ds:datastoreItem xmlns:ds="http://schemas.openxmlformats.org/officeDocument/2006/customXml" ds:itemID="{B9FEFA56-155D-43CE-9F8B-22A972C2C296}"/>
</file>

<file path=customXml/itemProps2.xml><?xml version="1.0" encoding="utf-8"?>
<ds:datastoreItem xmlns:ds="http://schemas.openxmlformats.org/officeDocument/2006/customXml" ds:itemID="{AF0F8A66-D884-4180-BC17-C839A42E9733}"/>
</file>

<file path=customXml/itemProps3.xml><?xml version="1.0" encoding="utf-8"?>
<ds:datastoreItem xmlns:ds="http://schemas.openxmlformats.org/officeDocument/2006/customXml" ds:itemID="{4AB5F319-0C66-4D2F-AAB5-3FC4BBE96619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1</TotalTime>
  <Words>480</Words>
  <Application>Microsoft Office PowerPoint</Application>
  <PresentationFormat>画面に合わせる (4:3)</PresentationFormat>
  <Paragraphs>61</Paragraphs>
  <Slides>5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5</vt:i4>
      </vt:variant>
    </vt:vector>
  </HeadingPairs>
  <TitlesOfParts>
    <vt:vector size="16" baseType="lpstr">
      <vt:lpstr>ＭＳ Ｐゴシック</vt:lpstr>
      <vt:lpstr>ＭＳ 明朝</vt:lpstr>
      <vt:lpstr>ヒラギノ角ゴ Pro W3</vt:lpstr>
      <vt:lpstr>Arial</vt:lpstr>
      <vt:lpstr>Calibri</vt:lpstr>
      <vt:lpstr>Symbol</vt:lpstr>
      <vt:lpstr>Times New Roman</vt:lpstr>
      <vt:lpstr>Times New Roman Bold</vt:lpstr>
      <vt:lpstr>Times New Roman Italic</vt:lpstr>
      <vt:lpstr>1_Office テーマ</vt:lpstr>
      <vt:lpstr>2_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koto Urai</dc:creator>
  <cp:lastModifiedBy>May</cp:lastModifiedBy>
  <cp:revision>64</cp:revision>
  <cp:lastPrinted>2015-06-19T11:16:35Z</cp:lastPrinted>
  <dcterms:created xsi:type="dcterms:W3CDTF">2015-03-31T09:41:43Z</dcterms:created>
  <dcterms:modified xsi:type="dcterms:W3CDTF">2015-11-30T01:31:39Z</dcterms:modified>
</cp:coreProperties>
</file>